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0AB91F-437E-4475-9ADE-7CE1DE83DB2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C7E99B-7F4E-43D7-9A45-C62397766F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62DEBA-F95E-493A-83A4-C1114FD69C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FD6642-F532-44C2-B156-806BBA1C07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23DABF-E636-4996-90B5-17897351F6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D33D1B-842D-4E36-AA66-8B0CB4846C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2233E4-B0BC-4F33-A687-61B86F2C4D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37C4AA-EE58-4026-8D5E-C0CB16C42B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FA4B02-8CB6-44E3-B462-D2B559DCCD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198276-3110-4882-95E1-B3C9EB82EE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5E9A61-8A53-48FE-8FD2-5AD0295717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8BD391-6C37-4B95-B18B-C0B225952F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0E37AA2-974F-4835-9835-F2E06931B62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tretch/>
        </p:blipFill>
        <p:spPr>
          <a:xfrm>
            <a:off x="-380880" y="376200"/>
            <a:ext cx="4271760" cy="32050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" descr=""/>
          <p:cNvPicPr/>
          <p:nvPr/>
        </p:nvPicPr>
        <p:blipFill>
          <a:blip r:embed="rId2"/>
          <a:stretch/>
        </p:blipFill>
        <p:spPr>
          <a:xfrm>
            <a:off x="-380880" y="3352680"/>
            <a:ext cx="4271760" cy="32054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3" descr=""/>
          <p:cNvPicPr/>
          <p:nvPr/>
        </p:nvPicPr>
        <p:blipFill>
          <a:blip r:embed="rId3"/>
          <a:stretch/>
        </p:blipFill>
        <p:spPr>
          <a:xfrm>
            <a:off x="3505320" y="230040"/>
            <a:ext cx="4271760" cy="320544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5" descr=""/>
          <p:cNvPicPr/>
          <p:nvPr/>
        </p:nvPicPr>
        <p:blipFill>
          <a:blip r:embed="rId4"/>
          <a:stretch/>
        </p:blipFill>
        <p:spPr>
          <a:xfrm>
            <a:off x="4038480" y="3576600"/>
            <a:ext cx="3511800" cy="2901960"/>
          </a:xfrm>
          <a:prstGeom prst="rect">
            <a:avLst/>
          </a:prstGeom>
          <a:ln w="0">
            <a:noFill/>
          </a:ln>
        </p:spPr>
      </p:pic>
      <p:sp>
        <p:nvSpPr>
          <p:cNvPr id="45" name="Text Box 18"/>
          <p:cNvSpPr/>
          <p:nvPr/>
        </p:nvSpPr>
        <p:spPr>
          <a:xfrm>
            <a:off x="7470360" y="685800"/>
            <a:ext cx="13449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ff0000"/>
                </a:solidFill>
                <a:latin typeface="Calibri"/>
              </a:rPr>
              <a:t>Whole bra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ff00"/>
                </a:solidFill>
                <a:latin typeface="Calibri"/>
              </a:rPr>
              <a:t>Occipital lob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ff"/>
                </a:solidFill>
                <a:latin typeface="Calibri"/>
              </a:rPr>
              <a:t>Heschl’s gyru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20"/>
          <p:cNvSpPr/>
          <p:nvPr/>
        </p:nvSpPr>
        <p:spPr>
          <a:xfrm>
            <a:off x="7575480" y="1752480"/>
            <a:ext cx="152640" cy="152640"/>
          </a:xfrm>
          <a:prstGeom prst="rect">
            <a:avLst/>
          </a:prstGeom>
          <a:solidFill>
            <a:srgbClr val="4f81b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21"/>
          <p:cNvSpPr/>
          <p:nvPr/>
        </p:nvSpPr>
        <p:spPr>
          <a:xfrm>
            <a:off x="7810200" y="1676520"/>
            <a:ext cx="971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5mm gri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22"/>
          <p:cNvSpPr/>
          <p:nvPr/>
        </p:nvSpPr>
        <p:spPr>
          <a:xfrm>
            <a:off x="7811640" y="2057400"/>
            <a:ext cx="1073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10mm gri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23"/>
          <p:cNvSpPr/>
          <p:nvPr/>
        </p:nvSpPr>
        <p:spPr>
          <a:xfrm>
            <a:off x="7811640" y="2452680"/>
            <a:ext cx="1073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20mm gri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AutoShape 24"/>
          <p:cNvSpPr/>
          <p:nvPr/>
        </p:nvSpPr>
        <p:spPr>
          <a:xfrm>
            <a:off x="7543800" y="2133720"/>
            <a:ext cx="228600" cy="152280"/>
          </a:xfrm>
          <a:prstGeom prst="triangle">
            <a:avLst>
              <a:gd name="adj" fmla="val 50000"/>
            </a:avLst>
          </a:prstGeom>
          <a:solidFill>
            <a:srgbClr val="4f81b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Oval 25"/>
          <p:cNvSpPr/>
          <p:nvPr/>
        </p:nvSpPr>
        <p:spPr>
          <a:xfrm>
            <a:off x="7620120" y="2514600"/>
            <a:ext cx="152280" cy="152280"/>
          </a:xfrm>
          <a:prstGeom prst="ellipse">
            <a:avLst/>
          </a:prstGeom>
          <a:solidFill>
            <a:srgbClr val="4f81b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4"/>
          <p:cNvSpPr/>
          <p:nvPr/>
        </p:nvSpPr>
        <p:spPr>
          <a:xfrm>
            <a:off x="7391520" y="533520"/>
            <a:ext cx="1600200" cy="2438280"/>
          </a:xfrm>
          <a:prstGeom prst="rect">
            <a:avLst/>
          </a:prstGeom>
          <a:noFill/>
          <a:ln w="25560">
            <a:solidFill>
              <a:srgbClr val="385d8a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5"/>
          <p:cNvSpPr/>
          <p:nvPr/>
        </p:nvSpPr>
        <p:spPr>
          <a:xfrm>
            <a:off x="836640" y="838080"/>
            <a:ext cx="101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N. voxel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6"/>
          <p:cNvSpPr/>
          <p:nvPr/>
        </p:nvSpPr>
        <p:spPr>
          <a:xfrm>
            <a:off x="4651560" y="762120"/>
            <a:ext cx="114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N. sensor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7"/>
          <p:cNvSpPr/>
          <p:nvPr/>
        </p:nvSpPr>
        <p:spPr>
          <a:xfrm>
            <a:off x="843840" y="3886200"/>
            <a:ext cx="1713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N. Extrema pair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8"/>
          <p:cNvSpPr/>
          <p:nvPr/>
        </p:nvSpPr>
        <p:spPr>
          <a:xfrm>
            <a:off x="4733640" y="3886200"/>
            <a:ext cx="1852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Significance level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9"/>
          <p:cNvSpPr/>
          <p:nvPr/>
        </p:nvSpPr>
        <p:spPr>
          <a:xfrm>
            <a:off x="2441520" y="2209680"/>
            <a:ext cx="4460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6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0"/>
          <p:cNvSpPr/>
          <p:nvPr/>
        </p:nvSpPr>
        <p:spPr>
          <a:xfrm>
            <a:off x="2441880" y="5334120"/>
            <a:ext cx="4244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6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1"/>
          <p:cNvSpPr/>
          <p:nvPr/>
        </p:nvSpPr>
        <p:spPr>
          <a:xfrm>
            <a:off x="6404400" y="2286000"/>
            <a:ext cx="429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6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2"/>
          <p:cNvSpPr/>
          <p:nvPr/>
        </p:nvSpPr>
        <p:spPr>
          <a:xfrm>
            <a:off x="4343400" y="6167520"/>
            <a:ext cx="3581280" cy="45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Calibri"/>
              </a:rPr>
              <a:t>        </a:t>
            </a:r>
            <a:r>
              <a:rPr b="0" lang="en-GB" sz="2400" spc="-1" strike="noStrike">
                <a:solidFill>
                  <a:srgbClr val="000000"/>
                </a:solidFill>
                <a:latin typeface="Calibri"/>
              </a:rPr>
              <a:t>A          B          C   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23"/>
          <p:cNvSpPr/>
          <p:nvPr/>
        </p:nvSpPr>
        <p:spPr>
          <a:xfrm>
            <a:off x="6784560" y="5334120"/>
            <a:ext cx="4626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36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24"/>
          <p:cNvSpPr/>
          <p:nvPr/>
        </p:nvSpPr>
        <p:spPr>
          <a:xfrm>
            <a:off x="1376640" y="15228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2" descr=""/>
          <p:cNvPicPr/>
          <p:nvPr/>
        </p:nvPicPr>
        <p:blipFill>
          <a:blip r:embed="rId1"/>
          <a:stretch/>
        </p:blipFill>
        <p:spPr>
          <a:xfrm>
            <a:off x="685800" y="1295280"/>
            <a:ext cx="5334120" cy="4000680"/>
          </a:xfrm>
          <a:prstGeom prst="rect">
            <a:avLst/>
          </a:prstGeom>
          <a:ln w="0">
            <a:noFill/>
          </a:ln>
        </p:spPr>
      </p:pic>
      <p:sp>
        <p:nvSpPr>
          <p:cNvPr id="64" name="Oval 4"/>
          <p:cNvSpPr/>
          <p:nvPr/>
        </p:nvSpPr>
        <p:spPr>
          <a:xfrm>
            <a:off x="6553080" y="2743200"/>
            <a:ext cx="152640" cy="152280"/>
          </a:xfrm>
          <a:prstGeom prst="ellipse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Multiply 5"/>
          <p:cNvSpPr/>
          <p:nvPr/>
        </p:nvSpPr>
        <p:spPr>
          <a:xfrm>
            <a:off x="6477120" y="3048120"/>
            <a:ext cx="228600" cy="152280"/>
          </a:xfrm>
          <a:custGeom>
            <a:avLst/>
            <a:gdLst>
              <a:gd name="textAreaLeft" fmla="*/ 45000 w 228600"/>
              <a:gd name="textAreaRight" fmla="*/ 183600 w 228600"/>
              <a:gd name="textAreaTop" fmla="*/ 21600 h 152280"/>
              <a:gd name="textAreaBottom" fmla="*/ 130680 h 152280"/>
            </a:gdLst>
            <a:ahLst/>
            <a:rect l="textAreaLeft" t="textAreaTop" r="textAreaRight" b="textAreaBottom"/>
            <a:pathLst>
              <a:path w="228600" h="152400">
                <a:moveTo>
                  <a:pt x="44963" y="51515"/>
                </a:moveTo>
                <a:lnTo>
                  <a:pt x="64845" y="21690"/>
                </a:lnTo>
                <a:lnTo>
                  <a:pt x="114300" y="54660"/>
                </a:lnTo>
                <a:lnTo>
                  <a:pt x="163755" y="21690"/>
                </a:lnTo>
                <a:lnTo>
                  <a:pt x="183637" y="51515"/>
                </a:lnTo>
                <a:lnTo>
                  <a:pt x="146610" y="76200"/>
                </a:lnTo>
                <a:lnTo>
                  <a:pt x="183637" y="100885"/>
                </a:lnTo>
                <a:lnTo>
                  <a:pt x="163755" y="130710"/>
                </a:lnTo>
                <a:lnTo>
                  <a:pt x="114300" y="97740"/>
                </a:lnTo>
                <a:lnTo>
                  <a:pt x="64845" y="130710"/>
                </a:lnTo>
                <a:lnTo>
                  <a:pt x="44963" y="100885"/>
                </a:lnTo>
                <a:lnTo>
                  <a:pt x="81990" y="76200"/>
                </a:lnTo>
                <a:close/>
              </a:path>
            </a:pathLst>
          </a:custGeom>
          <a:solidFill>
            <a:srgbClr val="2328e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6"/>
          <p:cNvSpPr/>
          <p:nvPr/>
        </p:nvSpPr>
        <p:spPr>
          <a:xfrm>
            <a:off x="6789240" y="2666880"/>
            <a:ext cx="996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Extre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Stat’ RF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7"/>
          <p:cNvSpPr/>
          <p:nvPr/>
        </p:nvSpPr>
        <p:spPr>
          <a:xfrm>
            <a:off x="2295000" y="5334120"/>
            <a:ext cx="240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Relative dipole momen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8"/>
          <p:cNvSpPr/>
          <p:nvPr/>
        </p:nvSpPr>
        <p:spPr>
          <a:xfrm rot="16200000">
            <a:off x="-561240" y="3084840"/>
            <a:ext cx="255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Significance of peak vox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9"/>
          <p:cNvSpPr/>
          <p:nvPr/>
        </p:nvSpPr>
        <p:spPr>
          <a:xfrm>
            <a:off x="1376640" y="15228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9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Gareth Barnes</dc:creator>
  <dc:description/>
  <dc:language>en-US</dc:language>
  <cp:lastModifiedBy>gbarnes</cp:lastModifiedBy>
  <dcterms:modified xsi:type="dcterms:W3CDTF">2011-01-28T14:49:49Z</dcterms:modified>
  <cp:revision>1065</cp:revision>
  <dc:subject/>
  <dc:title>Slide 1</dc:title>
</cp:coreProperties>
</file>